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10375" cy="9942513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7625" y="0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41FFE1-2FDA-D44A-9144-013A70DE8463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582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4725"/>
            <a:ext cx="5448300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7625" y="9444038"/>
            <a:ext cx="295116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AE29D4-F9C0-754F-8C8A-DA8D84AF5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106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B12DC-04FB-60F1-87C5-B0F1A39728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7AA82C-E27D-F26B-F116-D20E5CC604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3288AF-F1CA-A446-51EF-CDDF35DA6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B97FB-2179-7EA6-2790-3A76CC691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69AB59-B0F6-631C-158B-C7566C944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1412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24BBD-15BF-3F14-705E-C9CA9B00B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CE59C1-6D98-1C1D-423B-C2E7E96EEE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44D5F-A7C8-20D8-4DD6-5004576FF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8D78D9-163E-CFE0-6F71-1B4106199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2224D8-C6D6-A2D9-09BF-5F4C3A173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84335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7596B5-A36E-9DF7-6C0A-B6BEA224BD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6D1A1A-BE09-5A92-3D09-607AEBB2CC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1C659-CF5E-AC42-1A2F-0705FE986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76B3C1-0F70-6809-B79E-7C4642260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144725-EA0C-BA46-2ED6-542B8928C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92493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19796-766E-E8D4-5BF5-3F9CE904CE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EFC875-0BAC-715C-90C6-8D809AFAF3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DBE9E-F48D-D142-5DB2-5BF71CE35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A44FC9-43A0-1BC9-93E2-249B929F4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4B3AE-02DF-C699-A2FF-FD57A2446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27888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05AAB-CF5D-72B6-8B39-C0F066A61C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EFD1A7-9ED6-F018-6AA1-5ED936B3B4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61147-A1FE-DE69-3A9C-C263C0FCC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E9298A-98FE-6AAC-9329-C126D7317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AE61D-F251-2F0C-8807-43FE862F9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56122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8F750-BBF6-BBB2-E08F-B3960BA0A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2F4BD1-AA20-2D89-7F7B-8FCDB19FA6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93CF8B-615B-7FC2-E9A1-1906790B83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743F63-D557-D2A1-D96C-C88F0D7AB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01455B-60CF-E988-442F-37C1C5495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0E5D8B-3F84-C645-BF45-9A5FAE731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5825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D23CC-7FFC-A5F2-3529-C79B3BAFF6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A79239-37F3-C5BE-E96C-D0171726D4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2C8752-D49A-CCAA-4C89-F30B6F3D1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910571-4409-D942-E483-5359AE93A7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FD7832-BAE9-15C8-AA69-0BC49A143C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C46DD8-52AC-9436-7406-CD07F674B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2B9416-B262-57E0-7BEF-8E13A078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27C64D-0DFB-F472-7435-620C20B33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930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CAC312-7E80-3DC1-4A90-FCA7D55727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1991A1-B568-B402-2955-6D56E302C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C676B7-B32C-0644-3151-BF642A596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579172-C3A1-15A9-53CD-FB0E807A8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56316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B4B527-FAFB-3381-AD78-C2B622AB7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D0DCB6-2D9C-7D3F-671E-2458455D5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4E9AD7-09B2-EE48-809F-A374557E5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0533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27562-A819-8B5D-947A-B3EA2AEC7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812EC8-8464-F59E-AAB5-F2C1F7C852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722CDF-CD75-D1F3-766B-44A9E9F239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7AA520-76CD-5C26-944D-96D7502BF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C74ECD-8BBF-70D9-4755-31F7A65D2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A2216-7C3F-B511-11D5-A6C5C7A27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47636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6B37D-514E-2E93-039B-F096EA9606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07B12D-4B19-09E5-DB4E-A6A78C4ED0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A49FC2-C521-E47F-CF65-362641A75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8021B-06DE-BCA1-2606-114A2D51B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5F49D-4A91-6235-BB89-EB23F229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CFB664-A348-5D15-FEAB-5135506F3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4631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E6596E-1415-0810-179E-F5DDA04EFF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pl-P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141AB2-4287-EA08-F8DB-7DCE2F286A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l-P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1E1A7-AD13-0257-F6B6-0834B0C508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517D9-87C7-4B7D-AF0A-5A4D1DDA021E}" type="datetimeFigureOut">
              <a:rPr lang="pl-PL" smtClean="0"/>
              <a:t>17.07.2024</a:t>
            </a:fld>
            <a:endParaRPr lang="pl-P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3E4D9-F2B3-DCA2-1662-311E14D4F8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C18CA-9151-F835-59A5-97A97FD2D5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81E2D-F856-453F-B59C-C616AC109248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41407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7.emf"/><Relationship Id="rId18" Type="http://schemas.openxmlformats.org/officeDocument/2006/relationships/oleObject" Target="../embeddings/oleObject8.bin"/><Relationship Id="rId3" Type="http://schemas.openxmlformats.org/officeDocument/2006/relationships/image" Target="../media/image1.emf"/><Relationship Id="rId21" Type="http://schemas.openxmlformats.org/officeDocument/2006/relationships/image" Target="../media/image12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9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7.bin"/><Relationship Id="rId20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emf"/><Relationship Id="rId5" Type="http://schemas.openxmlformats.org/officeDocument/2006/relationships/image" Target="../media/image2.emf"/><Relationship Id="rId15" Type="http://schemas.openxmlformats.org/officeDocument/2006/relationships/image" Target="../media/image8.emf"/><Relationship Id="rId10" Type="http://schemas.openxmlformats.org/officeDocument/2006/relationships/image" Target="../media/image5.emf"/><Relationship Id="rId19" Type="http://schemas.openxmlformats.org/officeDocument/2006/relationships/image" Target="../media/image10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881697AA-0569-2739-BA74-B9BEBFA52362}"/>
              </a:ext>
            </a:extLst>
          </p:cNvPr>
          <p:cNvSpPr txBox="1"/>
          <p:nvPr/>
        </p:nvSpPr>
        <p:spPr>
          <a:xfrm>
            <a:off x="9647621" y="6545831"/>
            <a:ext cx="2501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DE91070A-3B9E-4573-8BF9-45FD62A8D3A3}"/>
              </a:ext>
            </a:extLst>
          </p:cNvPr>
          <p:cNvGrpSpPr/>
          <p:nvPr/>
        </p:nvGrpSpPr>
        <p:grpSpPr>
          <a:xfrm>
            <a:off x="276235" y="-29038"/>
            <a:ext cx="5794104" cy="6606498"/>
            <a:chOff x="276235" y="-29038"/>
            <a:chExt cx="5794104" cy="660649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A684476C-212C-E05D-F6DD-D8C8DD398D00}"/>
                </a:ext>
              </a:extLst>
            </p:cNvPr>
            <p:cNvGrpSpPr/>
            <p:nvPr/>
          </p:nvGrpSpPr>
          <p:grpSpPr>
            <a:xfrm>
              <a:off x="1049814" y="2371200"/>
              <a:ext cx="4703646" cy="2175211"/>
              <a:chOff x="392589" y="3247500"/>
              <a:chExt cx="4703646" cy="2175211"/>
            </a:xfrm>
          </p:grpSpPr>
          <p:graphicFrame>
            <p:nvGraphicFramePr>
              <p:cNvPr id="5" name="Obiekt 4">
                <a:extLst>
                  <a:ext uri="{FF2B5EF4-FFF2-40B4-BE49-F238E27FC236}">
                    <a16:creationId xmlns:a16="http://schemas.microsoft.com/office/drawing/2014/main" id="{3DA146A0-4960-F78E-CB2D-30C03B9BC058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392589" y="3262711"/>
              <a:ext cx="2290318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2426955" imgH="2289859" progId="Prism8.Document">
                      <p:embed/>
                    </p:oleObj>
                  </mc:Choice>
                  <mc:Fallback>
                    <p:oleObj name="Prism 8" r:id="rId2" imgW="2426955" imgH="2289859" progId="Prism8.Document">
                      <p:embed/>
                      <p:pic>
                        <p:nvPicPr>
                          <p:cNvPr id="5" name="Obiekt 4">
                            <a:extLst>
                              <a:ext uri="{FF2B5EF4-FFF2-40B4-BE49-F238E27FC236}">
                                <a16:creationId xmlns:a16="http://schemas.microsoft.com/office/drawing/2014/main" id="{3DA146A0-4960-F78E-CB2D-30C03B9BC05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392589" y="3262711"/>
                            <a:ext cx="2290318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iekt 5">
                <a:extLst>
                  <a:ext uri="{FF2B5EF4-FFF2-40B4-BE49-F238E27FC236}">
                    <a16:creationId xmlns:a16="http://schemas.microsoft.com/office/drawing/2014/main" id="{DB2CC4D1-53C1-571E-2A49-B6A8A9E5CBCE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865832" y="3247500"/>
              <a:ext cx="2230403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2363211" imgH="2289859" progId="Prism8.Document">
                      <p:embed/>
                    </p:oleObj>
                  </mc:Choice>
                  <mc:Fallback>
                    <p:oleObj name="Prism 8" r:id="rId4" imgW="2363211" imgH="2289859" progId="Prism8.Document">
                      <p:embed/>
                      <p:pic>
                        <p:nvPicPr>
                          <p:cNvPr id="6" name="Obiekt 5">
                            <a:extLst>
                              <a:ext uri="{FF2B5EF4-FFF2-40B4-BE49-F238E27FC236}">
                                <a16:creationId xmlns:a16="http://schemas.microsoft.com/office/drawing/2014/main" id="{DB2CC4D1-53C1-571E-2A49-B6A8A9E5CBC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865832" y="3247500"/>
                            <a:ext cx="2230403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C5447F7-D8D0-E563-8ADC-4F1F9EA17916}"/>
                  </a:ext>
                </a:extLst>
              </p:cNvPr>
              <p:cNvSpPr txBox="1"/>
              <p:nvPr/>
            </p:nvSpPr>
            <p:spPr>
              <a:xfrm>
                <a:off x="1009651" y="3262711"/>
                <a:ext cx="3663506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400" b="1" dirty="0"/>
                  <a:t>Early engraftment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E2F5B65-51FC-16E4-3BEB-0FB6CBE03FB7}"/>
                </a:ext>
              </a:extLst>
            </p:cNvPr>
            <p:cNvGrpSpPr/>
            <p:nvPr/>
          </p:nvGrpSpPr>
          <p:grpSpPr>
            <a:xfrm>
              <a:off x="1038225" y="15610"/>
              <a:ext cx="4781943" cy="2289175"/>
              <a:chOff x="419100" y="891910"/>
              <a:chExt cx="4781943" cy="2289175"/>
            </a:xfrm>
          </p:grpSpPr>
          <p:graphicFrame>
            <p:nvGraphicFramePr>
              <p:cNvPr id="3" name="Obiekt 2">
                <a:extLst>
                  <a:ext uri="{FF2B5EF4-FFF2-40B4-BE49-F238E27FC236}">
                    <a16:creationId xmlns:a16="http://schemas.microsoft.com/office/drawing/2014/main" id="{DA09CC8B-06F9-EEED-5CA1-08779C18D4BD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19100" y="985838"/>
              <a:ext cx="2298700" cy="21447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6" imgW="2405934" imgH="2246160" progId="Prism9.Document">
                      <p:embed/>
                    </p:oleObj>
                  </mc:Choice>
                  <mc:Fallback>
                    <p:oleObj name="Prism 9" r:id="rId6" imgW="2405934" imgH="2246160" progId="Prism9.Document">
                      <p:embed/>
                      <p:pic>
                        <p:nvPicPr>
                          <p:cNvPr id="3" name="Obiekt 2">
                            <a:extLst>
                              <a:ext uri="{FF2B5EF4-FFF2-40B4-BE49-F238E27FC236}">
                                <a16:creationId xmlns:a16="http://schemas.microsoft.com/office/drawing/2014/main" id="{DA09CC8B-06F9-EEED-5CA1-08779C18D4B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419100" y="985838"/>
                            <a:ext cx="2298700" cy="21447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iekt 3">
                <a:extLst>
                  <a:ext uri="{FF2B5EF4-FFF2-40B4-BE49-F238E27FC236}">
                    <a16:creationId xmlns:a16="http://schemas.microsoft.com/office/drawing/2014/main" id="{16DBBD5F-BEF4-0CD9-ADCA-AB61D28975F4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837256" y="891910"/>
              <a:ext cx="2363787" cy="22891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8" imgW="2363211" imgH="2289859" progId="Prism8.Document">
                      <p:embed/>
                    </p:oleObj>
                  </mc:Choice>
                  <mc:Fallback>
                    <p:oleObj name="Prism 8" r:id="rId8" imgW="2363211" imgH="2289859" progId="Prism8.Document">
                      <p:embed/>
                      <p:pic>
                        <p:nvPicPr>
                          <p:cNvPr id="4" name="Obiekt 3">
                            <a:extLst>
                              <a:ext uri="{FF2B5EF4-FFF2-40B4-BE49-F238E27FC236}">
                                <a16:creationId xmlns:a16="http://schemas.microsoft.com/office/drawing/2014/main" id="{16DBBD5F-BEF4-0CD9-ADCA-AB61D28975F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2837256" y="891910"/>
                            <a:ext cx="2363787" cy="22891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2F42839-AB6D-3E85-1632-AE7AAF0817AA}"/>
                  </a:ext>
                </a:extLst>
              </p:cNvPr>
              <p:cNvSpPr txBox="1"/>
              <p:nvPr/>
            </p:nvSpPr>
            <p:spPr>
              <a:xfrm>
                <a:off x="1314449" y="960787"/>
                <a:ext cx="308610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400" b="1" dirty="0"/>
                  <a:t>Homing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8DCD175-4745-4F55-D6AC-00D5BD84F5E4}"/>
                </a:ext>
              </a:extLst>
            </p:cNvPr>
            <p:cNvSpPr txBox="1"/>
            <p:nvPr/>
          </p:nvSpPr>
          <p:spPr>
            <a:xfrm>
              <a:off x="304612" y="-29038"/>
              <a:ext cx="34015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2000" b="1" dirty="0"/>
                <a:t>A</a:t>
              </a: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C762D4D1-0E17-40C6-C3D3-256DAC7E5B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4262" t="17207" b="60571"/>
            <a:stretch/>
          </p:blipFill>
          <p:spPr>
            <a:xfrm>
              <a:off x="1239302" y="4920853"/>
              <a:ext cx="1257637" cy="514351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9FE731F-4317-EB8A-44C6-EA8894098C8A}"/>
                </a:ext>
              </a:extLst>
            </p:cNvPr>
            <p:cNvSpPr txBox="1"/>
            <p:nvPr/>
          </p:nvSpPr>
          <p:spPr>
            <a:xfrm>
              <a:off x="1553320" y="4599752"/>
              <a:ext cx="356001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400" b="1" dirty="0"/>
                <a:t>Recovery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3D2DCF7-C9D6-C477-B158-271FC6E8E7EF}"/>
                </a:ext>
              </a:extLst>
            </p:cNvPr>
            <p:cNvGrpSpPr/>
            <p:nvPr/>
          </p:nvGrpSpPr>
          <p:grpSpPr>
            <a:xfrm>
              <a:off x="276235" y="4921460"/>
              <a:ext cx="2880000" cy="1656000"/>
              <a:chOff x="276235" y="4921460"/>
              <a:chExt cx="2880000" cy="1656000"/>
            </a:xfrm>
          </p:grpSpPr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7FED1BC0-D6F7-20F1-2B5E-D0CA3813D2E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/>
              <a:srcRect t="16625" r="25487"/>
              <a:stretch/>
            </p:blipFill>
            <p:spPr>
              <a:xfrm>
                <a:off x="276235" y="4921460"/>
                <a:ext cx="2880000" cy="1656000"/>
              </a:xfrm>
              <a:prstGeom prst="rect">
                <a:avLst/>
              </a:prstGeom>
            </p:spPr>
          </p:pic>
          <p:sp>
            <p:nvSpPr>
              <p:cNvPr id="16" name="pole tekstowe 10">
                <a:extLst>
                  <a:ext uri="{FF2B5EF4-FFF2-40B4-BE49-F238E27FC236}">
                    <a16:creationId xmlns:a16="http://schemas.microsoft.com/office/drawing/2014/main" id="{59227DEF-B4E3-4F2E-3F82-E8A838699CB1}"/>
                  </a:ext>
                </a:extLst>
              </p:cNvPr>
              <p:cNvSpPr txBox="1"/>
              <p:nvPr/>
            </p:nvSpPr>
            <p:spPr>
              <a:xfrm>
                <a:off x="1998819" y="5395725"/>
                <a:ext cx="295421" cy="29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350" dirty="0"/>
                  <a:t>*</a:t>
                </a:r>
              </a:p>
            </p:txBody>
          </p:sp>
          <p:sp>
            <p:nvSpPr>
              <p:cNvPr id="22" name="pole tekstowe 10">
                <a:extLst>
                  <a:ext uri="{FF2B5EF4-FFF2-40B4-BE49-F238E27FC236}">
                    <a16:creationId xmlns:a16="http://schemas.microsoft.com/office/drawing/2014/main" id="{0E870D79-8ABF-6D9E-A1F1-7F1E14B596FE}"/>
                  </a:ext>
                </a:extLst>
              </p:cNvPr>
              <p:cNvSpPr txBox="1"/>
              <p:nvPr/>
            </p:nvSpPr>
            <p:spPr>
              <a:xfrm>
                <a:off x="2390006" y="5246079"/>
                <a:ext cx="295421" cy="29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350" dirty="0"/>
                  <a:t>*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9D6F98AE-3A2F-9D86-E6ED-2071808791EA}"/>
                </a:ext>
              </a:extLst>
            </p:cNvPr>
            <p:cNvGrpSpPr/>
            <p:nvPr/>
          </p:nvGrpSpPr>
          <p:grpSpPr>
            <a:xfrm>
              <a:off x="3050876" y="4921460"/>
              <a:ext cx="2880000" cy="1656000"/>
              <a:chOff x="3050876" y="4921460"/>
              <a:chExt cx="2880000" cy="1656000"/>
            </a:xfrm>
          </p:grpSpPr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97928A6B-9201-F8EC-500B-FC200F8E6C4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1"/>
              <a:srcRect t="16714" r="24855"/>
              <a:stretch/>
            </p:blipFill>
            <p:spPr>
              <a:xfrm>
                <a:off x="3050876" y="4921460"/>
                <a:ext cx="2880000" cy="1656000"/>
              </a:xfrm>
              <a:prstGeom prst="rect">
                <a:avLst/>
              </a:prstGeom>
            </p:spPr>
          </p:pic>
          <p:sp>
            <p:nvSpPr>
              <p:cNvPr id="26" name="pole tekstowe 10">
                <a:extLst>
                  <a:ext uri="{FF2B5EF4-FFF2-40B4-BE49-F238E27FC236}">
                    <a16:creationId xmlns:a16="http://schemas.microsoft.com/office/drawing/2014/main" id="{40F1D166-5EC7-436D-14B3-370E069F16F1}"/>
                  </a:ext>
                </a:extLst>
              </p:cNvPr>
              <p:cNvSpPr txBox="1"/>
              <p:nvPr/>
            </p:nvSpPr>
            <p:spPr>
              <a:xfrm>
                <a:off x="5215137" y="5096433"/>
                <a:ext cx="295421" cy="299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350" dirty="0"/>
                  <a:t>*</a:t>
                </a:r>
              </a:p>
            </p:txBody>
          </p: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C3BE216-C622-1604-A034-B3690688DC4C}"/>
                </a:ext>
              </a:extLst>
            </p:cNvPr>
            <p:cNvSpPr/>
            <p:nvPr/>
          </p:nvSpPr>
          <p:spPr>
            <a:xfrm>
              <a:off x="276235" y="15610"/>
              <a:ext cx="5794104" cy="653368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57EB00A6-EAFC-AF15-BEBD-F9444CEE0CA7}"/>
              </a:ext>
            </a:extLst>
          </p:cNvPr>
          <p:cNvGrpSpPr/>
          <p:nvPr/>
        </p:nvGrpSpPr>
        <p:grpSpPr>
          <a:xfrm>
            <a:off x="6160381" y="-29038"/>
            <a:ext cx="5826905" cy="6580023"/>
            <a:chOff x="6160381" y="-29038"/>
            <a:chExt cx="5826905" cy="6580023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6CDABC0-DCD7-973C-AF76-035C82AD61B1}"/>
                </a:ext>
              </a:extLst>
            </p:cNvPr>
            <p:cNvGrpSpPr/>
            <p:nvPr/>
          </p:nvGrpSpPr>
          <p:grpSpPr>
            <a:xfrm>
              <a:off x="6509811" y="84138"/>
              <a:ext cx="4837957" cy="2163968"/>
              <a:chOff x="5481111" y="960438"/>
              <a:chExt cx="4837957" cy="2163968"/>
            </a:xfrm>
          </p:grpSpPr>
          <p:graphicFrame>
            <p:nvGraphicFramePr>
              <p:cNvPr id="9" name="Obiekt 14">
                <a:extLst>
                  <a:ext uri="{FF2B5EF4-FFF2-40B4-BE49-F238E27FC236}">
                    <a16:creationId xmlns:a16="http://schemas.microsoft.com/office/drawing/2014/main" id="{0960FB42-4C1B-0CE7-A8CD-72268577CC82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088665" y="960438"/>
              <a:ext cx="2230403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2" imgW="2363211" imgH="2289859" progId="Prism8.Document">
                      <p:embed/>
                    </p:oleObj>
                  </mc:Choice>
                  <mc:Fallback>
                    <p:oleObj name="Prism 8" r:id="rId12" imgW="2363211" imgH="2289859" progId="Prism8.Document">
                      <p:embed/>
                      <p:pic>
                        <p:nvPicPr>
                          <p:cNvPr id="9" name="Obiekt 14">
                            <a:extLst>
                              <a:ext uri="{FF2B5EF4-FFF2-40B4-BE49-F238E27FC236}">
                                <a16:creationId xmlns:a16="http://schemas.microsoft.com/office/drawing/2014/main" id="{0960FB42-4C1B-0CE7-A8CD-72268577CC8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8088665" y="960438"/>
                            <a:ext cx="2230403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Obiekt 13">
                <a:extLst>
                  <a:ext uri="{FF2B5EF4-FFF2-40B4-BE49-F238E27FC236}">
                    <a16:creationId xmlns:a16="http://schemas.microsoft.com/office/drawing/2014/main" id="{6F908768-9E3A-1A03-3610-C1BDBCE8C833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481111" y="964406"/>
              <a:ext cx="2290318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4" imgW="2426955" imgH="2289859" progId="Prism8.Document">
                      <p:embed/>
                    </p:oleObj>
                  </mc:Choice>
                  <mc:Fallback>
                    <p:oleObj name="Prism 8" r:id="rId14" imgW="2426955" imgH="2289859" progId="Prism8.Document">
                      <p:embed/>
                      <p:pic>
                        <p:nvPicPr>
                          <p:cNvPr id="10" name="Obiekt 13">
                            <a:extLst>
                              <a:ext uri="{FF2B5EF4-FFF2-40B4-BE49-F238E27FC236}">
                                <a16:creationId xmlns:a16="http://schemas.microsoft.com/office/drawing/2014/main" id="{6F908768-9E3A-1A03-3610-C1BDBCE8C83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5481111" y="964406"/>
                            <a:ext cx="2290318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542987D-CE4F-1430-90A3-B943BBA3F4ED}"/>
                  </a:ext>
                </a:extLst>
              </p:cNvPr>
              <p:cNvSpPr txBox="1"/>
              <p:nvPr/>
            </p:nvSpPr>
            <p:spPr>
              <a:xfrm>
                <a:off x="6174847" y="985936"/>
                <a:ext cx="332605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400" b="1" dirty="0"/>
                  <a:t>Homing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3759EFAB-E3DF-F28B-2801-0D6B1C459779}"/>
                </a:ext>
              </a:extLst>
            </p:cNvPr>
            <p:cNvGrpSpPr/>
            <p:nvPr/>
          </p:nvGrpSpPr>
          <p:grpSpPr>
            <a:xfrm>
              <a:off x="6520932" y="2398811"/>
              <a:ext cx="4836361" cy="2168982"/>
              <a:chOff x="5501757" y="3275111"/>
              <a:chExt cx="4836361" cy="2168982"/>
            </a:xfrm>
          </p:grpSpPr>
          <p:graphicFrame>
            <p:nvGraphicFramePr>
              <p:cNvPr id="7" name="Obiekt 16">
                <a:extLst>
                  <a:ext uri="{FF2B5EF4-FFF2-40B4-BE49-F238E27FC236}">
                    <a16:creationId xmlns:a16="http://schemas.microsoft.com/office/drawing/2014/main" id="{9E6C2A51-0DE9-33C9-3546-A82B317B42DD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107715" y="3281413"/>
              <a:ext cx="2230403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6" imgW="2363211" imgH="2289859" progId="Prism8.Document">
                      <p:embed/>
                    </p:oleObj>
                  </mc:Choice>
                  <mc:Fallback>
                    <p:oleObj name="Prism 8" r:id="rId16" imgW="2363211" imgH="2289859" progId="Prism8.Document">
                      <p:embed/>
                      <p:pic>
                        <p:nvPicPr>
                          <p:cNvPr id="7" name="Obiekt 16">
                            <a:extLst>
                              <a:ext uri="{FF2B5EF4-FFF2-40B4-BE49-F238E27FC236}">
                                <a16:creationId xmlns:a16="http://schemas.microsoft.com/office/drawing/2014/main" id="{9E6C2A51-0DE9-33C9-3546-A82B317B42D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8107715" y="3281413"/>
                            <a:ext cx="2230403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iekt 15">
                <a:extLst>
                  <a:ext uri="{FF2B5EF4-FFF2-40B4-BE49-F238E27FC236}">
                    <a16:creationId xmlns:a16="http://schemas.microsoft.com/office/drawing/2014/main" id="{DFD3C98A-F31A-0752-F3D0-CED67282002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501757" y="3284093"/>
              <a:ext cx="2290318" cy="21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8" imgW="2426955" imgH="2289859" progId="Prism8.Document">
                      <p:embed/>
                    </p:oleObj>
                  </mc:Choice>
                  <mc:Fallback>
                    <p:oleObj name="Prism 8" r:id="rId18" imgW="2426955" imgH="2289859" progId="Prism8.Document">
                      <p:embed/>
                      <p:pic>
                        <p:nvPicPr>
                          <p:cNvPr id="8" name="Obiekt 15">
                            <a:extLst>
                              <a:ext uri="{FF2B5EF4-FFF2-40B4-BE49-F238E27FC236}">
                                <a16:creationId xmlns:a16="http://schemas.microsoft.com/office/drawing/2014/main" id="{DFD3C98A-F31A-0752-F3D0-CED67282002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5501757" y="3284093"/>
                            <a:ext cx="2290318" cy="21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38FBE1C-35E1-6E7F-5A45-52E421B2A47A}"/>
                  </a:ext>
                </a:extLst>
              </p:cNvPr>
              <p:cNvSpPr txBox="1"/>
              <p:nvPr/>
            </p:nvSpPr>
            <p:spPr>
              <a:xfrm>
                <a:off x="6174614" y="3275111"/>
                <a:ext cx="3704563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400" b="1" dirty="0"/>
                  <a:t>Early</a:t>
                </a:r>
                <a:r>
                  <a:rPr lang="pl-PL" sz="1400" dirty="0"/>
                  <a:t> </a:t>
                </a:r>
                <a:r>
                  <a:rPr lang="pl-PL" sz="1400" b="1" dirty="0"/>
                  <a:t>engraftment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320D573-0C4C-7E27-2B4F-EB66F1DC87DC}"/>
                </a:ext>
              </a:extLst>
            </p:cNvPr>
            <p:cNvSpPr txBox="1"/>
            <p:nvPr/>
          </p:nvSpPr>
          <p:spPr>
            <a:xfrm>
              <a:off x="6179268" y="-29038"/>
              <a:ext cx="3289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2000" b="1" dirty="0"/>
                <a:t>B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D04A571-E785-134C-61A9-B8B96EE90EEA}"/>
                </a:ext>
              </a:extLst>
            </p:cNvPr>
            <p:cNvSpPr txBox="1"/>
            <p:nvPr/>
          </p:nvSpPr>
          <p:spPr>
            <a:xfrm>
              <a:off x="7241493" y="4559686"/>
              <a:ext cx="356001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400" b="1" dirty="0"/>
                <a:t>Recovery</a:t>
              </a:r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7B2B6BBF-26E8-51AE-1FA2-AD60073EC44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0"/>
            <a:srcRect t="14918" r="23232"/>
            <a:stretch/>
          </p:blipFill>
          <p:spPr>
            <a:xfrm>
              <a:off x="6160381" y="4933559"/>
              <a:ext cx="2880000" cy="161573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14E00A1-A2F9-AF35-A5E4-BE60165872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76659" t="17752" b="60025"/>
            <a:stretch/>
          </p:blipFill>
          <p:spPr>
            <a:xfrm>
              <a:off x="7183962" y="4882729"/>
              <a:ext cx="1133851" cy="512996"/>
            </a:xfrm>
            <a:prstGeom prst="rect">
              <a:avLst/>
            </a:prstGeom>
          </p:spPr>
        </p:pic>
        <p:sp>
          <p:nvSpPr>
            <p:cNvPr id="29" name="pole tekstowe 10">
              <a:extLst>
                <a:ext uri="{FF2B5EF4-FFF2-40B4-BE49-F238E27FC236}">
                  <a16:creationId xmlns:a16="http://schemas.microsoft.com/office/drawing/2014/main" id="{5CDC18D2-C29B-FB4C-E303-903B9DF0C5EB}"/>
                </a:ext>
              </a:extLst>
            </p:cNvPr>
            <p:cNvSpPr txBox="1"/>
            <p:nvPr/>
          </p:nvSpPr>
          <p:spPr>
            <a:xfrm>
              <a:off x="7842068" y="5294600"/>
              <a:ext cx="295421" cy="29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350" dirty="0"/>
                <a:t>*</a:t>
              </a:r>
            </a:p>
          </p:txBody>
        </p:sp>
        <p:sp>
          <p:nvSpPr>
            <p:cNvPr id="30" name="pole tekstowe 10">
              <a:extLst>
                <a:ext uri="{FF2B5EF4-FFF2-40B4-BE49-F238E27FC236}">
                  <a16:creationId xmlns:a16="http://schemas.microsoft.com/office/drawing/2014/main" id="{683D1438-4D3D-2EFD-E809-FCDCC457CE37}"/>
                </a:ext>
              </a:extLst>
            </p:cNvPr>
            <p:cNvSpPr txBox="1"/>
            <p:nvPr/>
          </p:nvSpPr>
          <p:spPr>
            <a:xfrm>
              <a:off x="8227531" y="5043916"/>
              <a:ext cx="295421" cy="29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350" dirty="0"/>
                <a:t>*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D22CE864-4A96-6FF5-D37A-5A14A124F3F2}"/>
                </a:ext>
              </a:extLst>
            </p:cNvPr>
            <p:cNvGrpSpPr/>
            <p:nvPr/>
          </p:nvGrpSpPr>
          <p:grpSpPr>
            <a:xfrm>
              <a:off x="8935022" y="4930985"/>
              <a:ext cx="2880000" cy="1620000"/>
              <a:chOff x="8801672" y="4864310"/>
              <a:chExt cx="2880000" cy="1620000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15451E27-F58A-7280-9C6A-15FD9CDCD79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/>
              <a:srcRect t="15583" r="22602"/>
              <a:stretch/>
            </p:blipFill>
            <p:spPr>
              <a:xfrm>
                <a:off x="8801672" y="4864310"/>
                <a:ext cx="2880000" cy="1620000"/>
              </a:xfrm>
              <a:prstGeom prst="rect">
                <a:avLst/>
              </a:prstGeom>
            </p:spPr>
          </p:pic>
          <p:sp>
            <p:nvSpPr>
              <p:cNvPr id="32" name="pole tekstowe 10">
                <a:extLst>
                  <a:ext uri="{FF2B5EF4-FFF2-40B4-BE49-F238E27FC236}">
                    <a16:creationId xmlns:a16="http://schemas.microsoft.com/office/drawing/2014/main" id="{88E84015-797B-40F4-FBB9-1AEDD1BB313A}"/>
                  </a:ext>
                </a:extLst>
              </p:cNvPr>
              <p:cNvSpPr txBox="1"/>
              <p:nvPr/>
            </p:nvSpPr>
            <p:spPr>
              <a:xfrm>
                <a:off x="10498157" y="5440903"/>
                <a:ext cx="295421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350" dirty="0"/>
                  <a:t>*</a:t>
                </a:r>
              </a:p>
            </p:txBody>
          </p:sp>
        </p:grp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53BD2C2D-5E9C-A136-7D24-C796CB058B72}"/>
                </a:ext>
              </a:extLst>
            </p:cNvPr>
            <p:cNvSpPr/>
            <p:nvPr/>
          </p:nvSpPr>
          <p:spPr>
            <a:xfrm>
              <a:off x="6193182" y="15610"/>
              <a:ext cx="5794104" cy="653368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</p:spTree>
    <p:extLst>
      <p:ext uri="{BB962C8B-B14F-4D97-AF65-F5344CB8AC3E}">
        <p14:creationId xmlns:p14="http://schemas.microsoft.com/office/powerpoint/2010/main" val="3225190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24</TotalTime>
  <Words>1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Office Theme</vt:lpstr>
      <vt:lpstr>Prism 8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ila Bujko</dc:creator>
  <cp:lastModifiedBy>Mariusz Ratajczak</cp:lastModifiedBy>
  <cp:revision>120</cp:revision>
  <cp:lastPrinted>2024-05-21T08:30:26Z</cp:lastPrinted>
  <dcterms:created xsi:type="dcterms:W3CDTF">2024-01-09T10:53:16Z</dcterms:created>
  <dcterms:modified xsi:type="dcterms:W3CDTF">2024-07-17T16:01:50Z</dcterms:modified>
</cp:coreProperties>
</file>